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94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3" Type="http://schemas.openxmlformats.org/officeDocument/2006/relationships/image" Target="../media/image10.png"/><Relationship Id="rId21" Type="http://schemas.openxmlformats.org/officeDocument/2006/relationships/image" Target="../media/image9.w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" descr="http://www.clker.com/cliparts/I/o/j/i/v/L/white-lab-mouse-md.png">
            <a:extLst>
              <a:ext uri="{FF2B5EF4-FFF2-40B4-BE49-F238E27FC236}">
                <a16:creationId xmlns:a16="http://schemas.microsoft.com/office/drawing/2014/main" id="{DCA43D1E-0281-4BD1-A71E-2B3739A290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8112894" y="812948"/>
            <a:ext cx="1373077" cy="2652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Oval 25">
            <a:extLst>
              <a:ext uri="{FF2B5EF4-FFF2-40B4-BE49-F238E27FC236}">
                <a16:creationId xmlns:a16="http://schemas.microsoft.com/office/drawing/2014/main" id="{CF516A94-1C70-4376-885D-D0409B059F33}"/>
              </a:ext>
            </a:extLst>
          </p:cNvPr>
          <p:cNvSpPr/>
          <p:nvPr/>
        </p:nvSpPr>
        <p:spPr>
          <a:xfrm>
            <a:off x="8454786" y="2053943"/>
            <a:ext cx="148718" cy="1707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625620">
              <a:defRPr/>
            </a:pPr>
            <a:endParaRPr lang="en-US" sz="1600" b="1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A0AC6195-3252-4425-9C46-2C0ECF107D0A}"/>
              </a:ext>
            </a:extLst>
          </p:cNvPr>
          <p:cNvSpPr/>
          <p:nvPr/>
        </p:nvSpPr>
        <p:spPr>
          <a:xfrm>
            <a:off x="8426602" y="2672394"/>
            <a:ext cx="176901" cy="258094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625620">
              <a:defRPr/>
            </a:pPr>
            <a:endParaRPr lang="en-US" sz="1600" b="1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FFE03363-5170-4937-B3FE-7DC002115B45}"/>
              </a:ext>
            </a:extLst>
          </p:cNvPr>
          <p:cNvCxnSpPr>
            <a:cxnSpLocks/>
          </p:cNvCxnSpPr>
          <p:nvPr/>
        </p:nvCxnSpPr>
        <p:spPr>
          <a:xfrm flipH="1">
            <a:off x="8649735" y="1805103"/>
            <a:ext cx="691509" cy="296114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09CBF3B-090D-4343-8403-98BFB49C35CE}"/>
              </a:ext>
            </a:extLst>
          </p:cNvPr>
          <p:cNvCxnSpPr/>
          <p:nvPr/>
        </p:nvCxnSpPr>
        <p:spPr>
          <a:xfrm flipH="1">
            <a:off x="8650333" y="1851817"/>
            <a:ext cx="848444" cy="809687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35C9C05-8358-47AA-B1CF-F91484D59E93}"/>
              </a:ext>
            </a:extLst>
          </p:cNvPr>
          <p:cNvSpPr txBox="1"/>
          <p:nvPr/>
        </p:nvSpPr>
        <p:spPr>
          <a:xfrm>
            <a:off x="9299275" y="1568079"/>
            <a:ext cx="1960271" cy="338554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lvl="0" defTabSz="91440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6F10-RFLuc-3 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AC79157-8BB7-415D-984C-AB2B09CE2F31}"/>
              </a:ext>
            </a:extLst>
          </p:cNvPr>
          <p:cNvCxnSpPr/>
          <p:nvPr/>
        </p:nvCxnSpPr>
        <p:spPr>
          <a:xfrm flipH="1">
            <a:off x="8650331" y="2726516"/>
            <a:ext cx="790030" cy="133412"/>
          </a:xfrm>
          <a:prstGeom prst="straightConnector1">
            <a:avLst/>
          </a:prstGeom>
          <a:ln>
            <a:solidFill>
              <a:srgbClr val="FF99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5BF9B31-0F63-4BFD-A0CF-F77B8B61F4EB}"/>
              </a:ext>
            </a:extLst>
          </p:cNvPr>
          <p:cNvSpPr txBox="1"/>
          <p:nvPr/>
        </p:nvSpPr>
        <p:spPr>
          <a:xfrm>
            <a:off x="9363861" y="2437063"/>
            <a:ext cx="1598105" cy="338554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el-1 T-cells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602236C1-BF9A-44D4-8CC4-FFE429DBE264}"/>
              </a:ext>
            </a:extLst>
          </p:cNvPr>
          <p:cNvCxnSpPr>
            <a:cxnSpLocks/>
          </p:cNvCxnSpPr>
          <p:nvPr/>
        </p:nvCxnSpPr>
        <p:spPr>
          <a:xfrm flipH="1">
            <a:off x="8669634" y="2347560"/>
            <a:ext cx="729458" cy="425876"/>
          </a:xfrm>
          <a:prstGeom prst="straightConnector1">
            <a:avLst/>
          </a:prstGeom>
          <a:ln>
            <a:solidFill>
              <a:schemeClr val="accent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F3BB987-03E0-48C4-9B92-DAED5BDCE334}"/>
              </a:ext>
            </a:extLst>
          </p:cNvPr>
          <p:cNvSpPr txBox="1"/>
          <p:nvPr/>
        </p:nvSpPr>
        <p:spPr>
          <a:xfrm>
            <a:off x="9317842" y="2040829"/>
            <a:ext cx="1720626" cy="338554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defTabSz="162562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DOX 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FE56B0C0-5AC2-412D-8FD8-3A5DC9CF6B8B}"/>
              </a:ext>
            </a:extLst>
          </p:cNvPr>
          <p:cNvCxnSpPr/>
          <p:nvPr/>
        </p:nvCxnSpPr>
        <p:spPr>
          <a:xfrm flipV="1">
            <a:off x="2834310" y="2674733"/>
            <a:ext cx="4494364" cy="9312"/>
          </a:xfrm>
          <a:prstGeom prst="straightConnector1">
            <a:avLst/>
          </a:prstGeom>
          <a:ln w="12700" cmpd="sng">
            <a:solidFill>
              <a:schemeClr val="tx1"/>
            </a:solidFill>
            <a:headEnd type="diamond"/>
            <a:tail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64E07429-EB4F-4CF1-9211-81F4D0A8FCC4}"/>
              </a:ext>
            </a:extLst>
          </p:cNvPr>
          <p:cNvSpPr txBox="1"/>
          <p:nvPr/>
        </p:nvSpPr>
        <p:spPr>
          <a:xfrm>
            <a:off x="2041767" y="2246296"/>
            <a:ext cx="59891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625620">
              <a:tabLst>
                <a:tab pos="1219215" algn="l"/>
                <a:tab pos="1430885" algn="l"/>
              </a:tabLst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:  0           4               10     12    14       17                                                                                         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9AF4ABF-558F-49DD-A356-1A438046C44B}"/>
              </a:ext>
            </a:extLst>
          </p:cNvPr>
          <p:cNvSpPr txBox="1"/>
          <p:nvPr/>
        </p:nvSpPr>
        <p:spPr>
          <a:xfrm>
            <a:off x="1949984" y="841073"/>
            <a:ext cx="1858201" cy="33855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pPr lvl="0" defTabSz="91440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6F10-RFLuc-3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DD1083-F294-4561-ABB2-0B4D62777627}"/>
              </a:ext>
            </a:extLst>
          </p:cNvPr>
          <p:cNvSpPr txBox="1"/>
          <p:nvPr/>
        </p:nvSpPr>
        <p:spPr>
          <a:xfrm>
            <a:off x="4865068" y="1316757"/>
            <a:ext cx="1474250" cy="584775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pPr algn="ctr" defTabSz="162562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DOX </a:t>
            </a:r>
          </a:p>
          <a:p>
            <a:pPr algn="ctr" defTabSz="162562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.t., T</a:t>
            </a:r>
            <a:r>
              <a:rPr lang="en-US" sz="16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or</a:t>
            </a: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8F644D1-994F-4E5D-8E24-B296773F2418}"/>
              </a:ext>
            </a:extLst>
          </p:cNvPr>
          <p:cNvCxnSpPr/>
          <p:nvPr/>
        </p:nvCxnSpPr>
        <p:spPr>
          <a:xfrm>
            <a:off x="2854268" y="1449396"/>
            <a:ext cx="0" cy="817092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2D50DAB-941F-4987-94F0-F423608741E9}"/>
              </a:ext>
            </a:extLst>
          </p:cNvPr>
          <p:cNvCxnSpPr/>
          <p:nvPr/>
        </p:nvCxnSpPr>
        <p:spPr>
          <a:xfrm>
            <a:off x="2839698" y="2557775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584E099-884A-4B50-96CB-D13390DF9C8B}"/>
              </a:ext>
            </a:extLst>
          </p:cNvPr>
          <p:cNvCxnSpPr/>
          <p:nvPr/>
        </p:nvCxnSpPr>
        <p:spPr>
          <a:xfrm>
            <a:off x="5100185" y="2557775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7F2574D-7235-4420-9297-837D67729261}"/>
              </a:ext>
            </a:extLst>
          </p:cNvPr>
          <p:cNvCxnSpPr/>
          <p:nvPr/>
        </p:nvCxnSpPr>
        <p:spPr>
          <a:xfrm rot="10800000">
            <a:off x="4601250" y="2868803"/>
            <a:ext cx="0" cy="305556"/>
          </a:xfrm>
          <a:prstGeom prst="straightConnector1">
            <a:avLst/>
          </a:prstGeom>
          <a:ln>
            <a:solidFill>
              <a:srgbClr val="FF99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A442FC2-69D4-47D7-9564-75D0A6CAADEF}"/>
              </a:ext>
            </a:extLst>
          </p:cNvPr>
          <p:cNvCxnSpPr/>
          <p:nvPr/>
        </p:nvCxnSpPr>
        <p:spPr>
          <a:xfrm>
            <a:off x="5570309" y="2557786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22338B0-BA99-4499-A7B4-A660E806D7C2}"/>
              </a:ext>
            </a:extLst>
          </p:cNvPr>
          <p:cNvCxnSpPr/>
          <p:nvPr/>
        </p:nvCxnSpPr>
        <p:spPr>
          <a:xfrm>
            <a:off x="6153058" y="2557775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3E85B8B-2ACD-44C2-B4B5-DB408B3BBF1D}"/>
              </a:ext>
            </a:extLst>
          </p:cNvPr>
          <p:cNvCxnSpPr/>
          <p:nvPr/>
        </p:nvCxnSpPr>
        <p:spPr>
          <a:xfrm>
            <a:off x="3584316" y="2557777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ADC00BA-81EA-40F2-84ED-A386CA63AB9B}"/>
              </a:ext>
            </a:extLst>
          </p:cNvPr>
          <p:cNvCxnSpPr/>
          <p:nvPr/>
        </p:nvCxnSpPr>
        <p:spPr>
          <a:xfrm>
            <a:off x="5120656" y="1996838"/>
            <a:ext cx="0" cy="252526"/>
          </a:xfrm>
          <a:prstGeom prst="straightConnector1">
            <a:avLst/>
          </a:prstGeom>
          <a:ln>
            <a:solidFill>
              <a:schemeClr val="accent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C5F3AD0-5473-4346-AD57-CEEBB33D247A}"/>
              </a:ext>
            </a:extLst>
          </p:cNvPr>
          <p:cNvCxnSpPr/>
          <p:nvPr/>
        </p:nvCxnSpPr>
        <p:spPr>
          <a:xfrm>
            <a:off x="5575868" y="1996838"/>
            <a:ext cx="0" cy="252526"/>
          </a:xfrm>
          <a:prstGeom prst="straightConnector1">
            <a:avLst/>
          </a:prstGeom>
          <a:ln>
            <a:solidFill>
              <a:schemeClr val="accent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770E0A8-4A19-45FD-98E5-D17802402E91}"/>
              </a:ext>
            </a:extLst>
          </p:cNvPr>
          <p:cNvCxnSpPr/>
          <p:nvPr/>
        </p:nvCxnSpPr>
        <p:spPr>
          <a:xfrm>
            <a:off x="6158052" y="1996838"/>
            <a:ext cx="0" cy="252526"/>
          </a:xfrm>
          <a:prstGeom prst="straightConnector1">
            <a:avLst/>
          </a:prstGeom>
          <a:ln>
            <a:solidFill>
              <a:schemeClr val="accent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567A0E79-AA4E-4821-B451-C556816D7F54}"/>
              </a:ext>
            </a:extLst>
          </p:cNvPr>
          <p:cNvCxnSpPr/>
          <p:nvPr/>
        </p:nvCxnSpPr>
        <p:spPr>
          <a:xfrm>
            <a:off x="4604400" y="2570568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6C58CD14-6402-4859-A1BD-B19FBAD6C6CD}"/>
              </a:ext>
            </a:extLst>
          </p:cNvPr>
          <p:cNvSpPr txBox="1"/>
          <p:nvPr/>
        </p:nvSpPr>
        <p:spPr>
          <a:xfrm>
            <a:off x="3439233" y="3100184"/>
            <a:ext cx="2891176" cy="338554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pPr algn="ctr" defTabSz="1625620">
              <a:defRPr/>
            </a:pPr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el-1 T-cells (i.t., Tumor 1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DDE7DCE-2435-4C1F-9A6E-58F57BC02012}"/>
              </a:ext>
            </a:extLst>
          </p:cNvPr>
          <p:cNvCxnSpPr/>
          <p:nvPr/>
        </p:nvCxnSpPr>
        <p:spPr>
          <a:xfrm>
            <a:off x="7324121" y="2553521"/>
            <a:ext cx="0" cy="242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8CA8F6C-C29B-44D8-8CCA-57C883E7EAF2}"/>
              </a:ext>
            </a:extLst>
          </p:cNvPr>
          <p:cNvCxnSpPr/>
          <p:nvPr/>
        </p:nvCxnSpPr>
        <p:spPr>
          <a:xfrm>
            <a:off x="3574958" y="1667497"/>
            <a:ext cx="0" cy="613893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2468E957-E045-4617-AC88-489F2C6B8A5F}"/>
              </a:ext>
            </a:extLst>
          </p:cNvPr>
          <p:cNvSpPr txBox="1"/>
          <p:nvPr/>
        </p:nvSpPr>
        <p:spPr>
          <a:xfrm>
            <a:off x="720294" y="673290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0D277A5-75CA-4C87-907F-7D6C66FFDA18}"/>
              </a:ext>
            </a:extLst>
          </p:cNvPr>
          <p:cNvSpPr txBox="1"/>
          <p:nvPr/>
        </p:nvSpPr>
        <p:spPr>
          <a:xfrm>
            <a:off x="2085936" y="1112634"/>
            <a:ext cx="1243546" cy="311175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pPr defTabSz="1625620">
              <a:defRPr/>
            </a:pPr>
            <a:r>
              <a:rPr lang="en-US" sz="1422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1 </a:t>
            </a:r>
            <a:r>
              <a:rPr lang="en-US" sz="1422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endParaRPr lang="en-US" sz="1422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B2860A17-0FD4-45E0-BB6E-103026DB41BE}"/>
              </a:ext>
            </a:extLst>
          </p:cNvPr>
          <p:cNvSpPr txBox="1"/>
          <p:nvPr/>
        </p:nvSpPr>
        <p:spPr>
          <a:xfrm>
            <a:off x="2890262" y="1344130"/>
            <a:ext cx="1243546" cy="311175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pPr defTabSz="1625620">
              <a:defRPr/>
            </a:pPr>
            <a:r>
              <a:rPr lang="en-US" sz="1422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2 </a:t>
            </a:r>
            <a:r>
              <a:rPr lang="en-US" sz="1422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endParaRPr lang="en-US" sz="1422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0F75FB15-4F04-4E73-B38D-3A0DB4AFBB33}"/>
              </a:ext>
            </a:extLst>
          </p:cNvPr>
          <p:cNvGrpSpPr/>
          <p:nvPr/>
        </p:nvGrpSpPr>
        <p:grpSpPr>
          <a:xfrm>
            <a:off x="1436482" y="4388448"/>
            <a:ext cx="9848617" cy="3006452"/>
            <a:chOff x="614931" y="764026"/>
            <a:chExt cx="6299418" cy="2171014"/>
          </a:xfrm>
        </p:grpSpPr>
        <p:graphicFrame>
          <p:nvGraphicFramePr>
            <p:cNvPr id="161" name="Object 160">
              <a:extLst>
                <a:ext uri="{FF2B5EF4-FFF2-40B4-BE49-F238E27FC236}">
                  <a16:creationId xmlns:a16="http://schemas.microsoft.com/office/drawing/2014/main" id="{264A4413-35E7-4505-9AD5-8183239B012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14931" y="764026"/>
            <a:ext cx="1579367" cy="21479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r:id="rId4" imgW="2539440" imgH="3453840" progId="">
                    <p:embed/>
                  </p:oleObj>
                </mc:Choice>
                <mc:Fallback>
                  <p:oleObj r:id="rId4" imgW="2539440" imgH="3453840" progId="">
                    <p:embed/>
                    <p:pic>
                      <p:nvPicPr>
                        <p:cNvPr id="161" name="Object 160">
                          <a:extLst>
                            <a:ext uri="{FF2B5EF4-FFF2-40B4-BE49-F238E27FC236}">
                              <a16:creationId xmlns:a16="http://schemas.microsoft.com/office/drawing/2014/main" id="{264A4413-35E7-4505-9AD5-8183239B01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14931" y="764026"/>
                          <a:ext cx="1579367" cy="21479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0" name="Object 179">
              <a:extLst>
                <a:ext uri="{FF2B5EF4-FFF2-40B4-BE49-F238E27FC236}">
                  <a16:creationId xmlns:a16="http://schemas.microsoft.com/office/drawing/2014/main" id="{ED080E92-66CB-49CF-9A95-0EC20E8EA74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07836" y="764026"/>
            <a:ext cx="1658335" cy="21400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r:id="rId6" imgW="2666520" imgH="3441240" progId="">
                    <p:embed/>
                  </p:oleObj>
                </mc:Choice>
                <mc:Fallback>
                  <p:oleObj r:id="rId6" imgW="2666520" imgH="3441240" progId="">
                    <p:embed/>
                    <p:pic>
                      <p:nvPicPr>
                        <p:cNvPr id="180" name="Object 179">
                          <a:extLst>
                            <a:ext uri="{FF2B5EF4-FFF2-40B4-BE49-F238E27FC236}">
                              <a16:creationId xmlns:a16="http://schemas.microsoft.com/office/drawing/2014/main" id="{ED080E92-66CB-49CF-9A95-0EC20E8EA74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207836" y="764026"/>
                          <a:ext cx="1658335" cy="21400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1" name="Object 180">
              <a:extLst>
                <a:ext uri="{FF2B5EF4-FFF2-40B4-BE49-F238E27FC236}">
                  <a16:creationId xmlns:a16="http://schemas.microsoft.com/office/drawing/2014/main" id="{FA6767A5-0372-43EC-B675-06D133278F2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671244" y="771308"/>
            <a:ext cx="1674129" cy="21558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r:id="rId8" imgW="2691720" imgH="3466440" progId="">
                    <p:embed/>
                  </p:oleObj>
                </mc:Choice>
                <mc:Fallback>
                  <p:oleObj r:id="rId8" imgW="2691720" imgH="3466440" progId="">
                    <p:embed/>
                    <p:pic>
                      <p:nvPicPr>
                        <p:cNvPr id="181" name="Object 180">
                          <a:extLst>
                            <a:ext uri="{FF2B5EF4-FFF2-40B4-BE49-F238E27FC236}">
                              <a16:creationId xmlns:a16="http://schemas.microsoft.com/office/drawing/2014/main" id="{FA6767A5-0372-43EC-B675-06D133278F2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671244" y="771308"/>
                          <a:ext cx="1674129" cy="21558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2" name="Object 181">
              <a:extLst>
                <a:ext uri="{FF2B5EF4-FFF2-40B4-BE49-F238E27FC236}">
                  <a16:creationId xmlns:a16="http://schemas.microsoft.com/office/drawing/2014/main" id="{0721DEF0-AED1-499F-A336-309D7D95C13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342879" y="771308"/>
            <a:ext cx="1571470" cy="21637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r:id="rId10" imgW="2526840" imgH="3479040" progId="">
                    <p:embed/>
                  </p:oleObj>
                </mc:Choice>
                <mc:Fallback>
                  <p:oleObj r:id="rId10" imgW="2526840" imgH="3479040" progId="">
                    <p:embed/>
                    <p:pic>
                      <p:nvPicPr>
                        <p:cNvPr id="182" name="Object 181">
                          <a:extLst>
                            <a:ext uri="{FF2B5EF4-FFF2-40B4-BE49-F238E27FC236}">
                              <a16:creationId xmlns:a16="http://schemas.microsoft.com/office/drawing/2014/main" id="{0721DEF0-AED1-499F-A336-309D7D95C1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342879" y="771308"/>
                          <a:ext cx="1571470" cy="21637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AB87DB9D-4B8C-4C6D-91C7-CB6AAB0037D9}"/>
              </a:ext>
            </a:extLst>
          </p:cNvPr>
          <p:cNvGrpSpPr/>
          <p:nvPr/>
        </p:nvGrpSpPr>
        <p:grpSpPr>
          <a:xfrm>
            <a:off x="1488254" y="7567496"/>
            <a:ext cx="9846604" cy="3073399"/>
            <a:chOff x="626776" y="3000107"/>
            <a:chExt cx="6298131" cy="2183474"/>
          </a:xfrm>
        </p:grpSpPr>
        <p:graphicFrame>
          <p:nvGraphicFramePr>
            <p:cNvPr id="184" name="Object 183">
              <a:extLst>
                <a:ext uri="{FF2B5EF4-FFF2-40B4-BE49-F238E27FC236}">
                  <a16:creationId xmlns:a16="http://schemas.microsoft.com/office/drawing/2014/main" id="{837C5239-C58E-4B48-8D96-B1E32B07FF7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26776" y="3000107"/>
            <a:ext cx="1555676" cy="21637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r:id="rId12" imgW="2501280" imgH="3479040" progId="">
                    <p:embed/>
                  </p:oleObj>
                </mc:Choice>
                <mc:Fallback>
                  <p:oleObj r:id="rId12" imgW="2501280" imgH="3479040" progId="">
                    <p:embed/>
                    <p:pic>
                      <p:nvPicPr>
                        <p:cNvPr id="184" name="Object 183">
                          <a:extLst>
                            <a:ext uri="{FF2B5EF4-FFF2-40B4-BE49-F238E27FC236}">
                              <a16:creationId xmlns:a16="http://schemas.microsoft.com/office/drawing/2014/main" id="{837C5239-C58E-4B48-8D96-B1E32B07FF7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26776" y="3000107"/>
                          <a:ext cx="1555676" cy="21637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5" name="Object 184">
              <a:extLst>
                <a:ext uri="{FF2B5EF4-FFF2-40B4-BE49-F238E27FC236}">
                  <a16:creationId xmlns:a16="http://schemas.microsoft.com/office/drawing/2014/main" id="{CCBF1E94-A63A-4800-8804-5ABA71393B3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07836" y="3023797"/>
            <a:ext cx="1563573" cy="21400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r:id="rId14" imgW="2514240" imgH="3441240" progId="">
                    <p:embed/>
                  </p:oleObj>
                </mc:Choice>
                <mc:Fallback>
                  <p:oleObj r:id="rId14" imgW="2514240" imgH="3441240" progId="">
                    <p:embed/>
                    <p:pic>
                      <p:nvPicPr>
                        <p:cNvPr id="185" name="Object 184">
                          <a:extLst>
                            <a:ext uri="{FF2B5EF4-FFF2-40B4-BE49-F238E27FC236}">
                              <a16:creationId xmlns:a16="http://schemas.microsoft.com/office/drawing/2014/main" id="{CCBF1E94-A63A-4800-8804-5ABA71393B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207836" y="3023797"/>
                          <a:ext cx="1563573" cy="21400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6" name="Object 185">
              <a:extLst>
                <a:ext uri="{FF2B5EF4-FFF2-40B4-BE49-F238E27FC236}">
                  <a16:creationId xmlns:a16="http://schemas.microsoft.com/office/drawing/2014/main" id="{75485954-C8CA-4832-B92F-651D9F40150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71409" y="3023797"/>
            <a:ext cx="1571470" cy="21400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2" r:id="rId16" imgW="2526840" imgH="3441240" progId="">
                    <p:embed/>
                  </p:oleObj>
                </mc:Choice>
                <mc:Fallback>
                  <p:oleObj r:id="rId16" imgW="2526840" imgH="3441240" progId="">
                    <p:embed/>
                    <p:pic>
                      <p:nvPicPr>
                        <p:cNvPr id="186" name="Object 185">
                          <a:extLst>
                            <a:ext uri="{FF2B5EF4-FFF2-40B4-BE49-F238E27FC236}">
                              <a16:creationId xmlns:a16="http://schemas.microsoft.com/office/drawing/2014/main" id="{75485954-C8CA-4832-B92F-651D9F40150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771409" y="3023797"/>
                          <a:ext cx="1571470" cy="21400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7" name="Object 186">
              <a:extLst>
                <a:ext uri="{FF2B5EF4-FFF2-40B4-BE49-F238E27FC236}">
                  <a16:creationId xmlns:a16="http://schemas.microsoft.com/office/drawing/2014/main" id="{F20B48C5-9DD2-4080-BB69-C554AF6661D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234985" y="3004055"/>
            <a:ext cx="1689922" cy="21795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r:id="rId18" imgW="2717280" imgH="3504600" progId="">
                    <p:embed/>
                  </p:oleObj>
                </mc:Choice>
                <mc:Fallback>
                  <p:oleObj r:id="rId18" imgW="2717280" imgH="3504600" progId="">
                    <p:embed/>
                    <p:pic>
                      <p:nvPicPr>
                        <p:cNvPr id="187" name="Object 186">
                          <a:extLst>
                            <a:ext uri="{FF2B5EF4-FFF2-40B4-BE49-F238E27FC236}">
                              <a16:creationId xmlns:a16="http://schemas.microsoft.com/office/drawing/2014/main" id="{F20B48C5-9DD2-4080-BB69-C554AF6661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5234985" y="3004055"/>
                          <a:ext cx="1689922" cy="21795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88" name="TextBox 187">
            <a:extLst>
              <a:ext uri="{FF2B5EF4-FFF2-40B4-BE49-F238E27FC236}">
                <a16:creationId xmlns:a16="http://schemas.microsoft.com/office/drawing/2014/main" id="{5468DC4D-EDAA-45A9-BDCE-BB66E4F480B7}"/>
              </a:ext>
            </a:extLst>
          </p:cNvPr>
          <p:cNvSpPr txBox="1"/>
          <p:nvPr/>
        </p:nvSpPr>
        <p:spPr>
          <a:xfrm>
            <a:off x="2441774" y="3738419"/>
            <a:ext cx="1001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FEDE8CE2-BC5E-470A-90EB-6141DC093123}"/>
              </a:ext>
            </a:extLst>
          </p:cNvPr>
          <p:cNvSpPr txBox="1"/>
          <p:nvPr/>
        </p:nvSpPr>
        <p:spPr>
          <a:xfrm>
            <a:off x="4840738" y="3741045"/>
            <a:ext cx="12966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RGDOX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7BD93743-4FA9-4D5F-B157-AF1FBE161AF9}"/>
              </a:ext>
            </a:extLst>
          </p:cNvPr>
          <p:cNvSpPr txBox="1"/>
          <p:nvPr/>
        </p:nvSpPr>
        <p:spPr>
          <a:xfrm>
            <a:off x="7134420" y="3745146"/>
            <a:ext cx="1556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mel-1 T cells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4FA65169-AD73-4CA3-B254-46932A69F96B}"/>
              </a:ext>
            </a:extLst>
          </p:cNvPr>
          <p:cNvSpPr txBox="1"/>
          <p:nvPr/>
        </p:nvSpPr>
        <p:spPr>
          <a:xfrm>
            <a:off x="8999719" y="3745146"/>
            <a:ext cx="21678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RGDOX + pmel-1 T cells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0168366-DE69-4F6D-8FD5-1F9C8B398F5F}"/>
              </a:ext>
            </a:extLst>
          </p:cNvPr>
          <p:cNvSpPr txBox="1"/>
          <p:nvPr/>
        </p:nvSpPr>
        <p:spPr>
          <a:xfrm>
            <a:off x="868604" y="4090374"/>
            <a:ext cx="13111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umor 1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D114C7A9-676D-4841-926E-AD370BC48B8E}"/>
              </a:ext>
            </a:extLst>
          </p:cNvPr>
          <p:cNvSpPr txBox="1"/>
          <p:nvPr/>
        </p:nvSpPr>
        <p:spPr>
          <a:xfrm>
            <a:off x="868604" y="7246243"/>
            <a:ext cx="13111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umor 2</a:t>
            </a:r>
          </a:p>
        </p:txBody>
      </p:sp>
      <p:graphicFrame>
        <p:nvGraphicFramePr>
          <p:cNvPr id="194" name="Object 193">
            <a:extLst>
              <a:ext uri="{FF2B5EF4-FFF2-40B4-BE49-F238E27FC236}">
                <a16:creationId xmlns:a16="http://schemas.microsoft.com/office/drawing/2014/main" id="{95D9DD3E-8476-4582-BEDB-64132EAC3D9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081938" y="10837984"/>
          <a:ext cx="4291095" cy="2571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r:id="rId20" imgW="4304520" imgH="2895120" progId="">
                  <p:embed/>
                </p:oleObj>
              </mc:Choice>
              <mc:Fallback>
                <p:oleObj r:id="rId20" imgW="4304520" imgH="2895120" progId="">
                  <p:embed/>
                  <p:pic>
                    <p:nvPicPr>
                      <p:cNvPr id="194" name="Object 193">
                        <a:extLst>
                          <a:ext uri="{FF2B5EF4-FFF2-40B4-BE49-F238E27FC236}">
                            <a16:creationId xmlns:a16="http://schemas.microsoft.com/office/drawing/2014/main" id="{95D9DD3E-8476-4582-BEDB-64132EAC3D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081938" y="10837984"/>
                        <a:ext cx="4291095" cy="2571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5" name="TextBox 194">
            <a:extLst>
              <a:ext uri="{FF2B5EF4-FFF2-40B4-BE49-F238E27FC236}">
                <a16:creationId xmlns:a16="http://schemas.microsoft.com/office/drawing/2014/main" id="{FA7BD2B0-3530-4E1A-969B-22EEBEE77633}"/>
              </a:ext>
            </a:extLst>
          </p:cNvPr>
          <p:cNvSpPr txBox="1"/>
          <p:nvPr/>
        </p:nvSpPr>
        <p:spPr>
          <a:xfrm>
            <a:off x="7472243" y="11103003"/>
            <a:ext cx="801312" cy="311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CD66F965-9D71-4DAB-BA0E-E267EAFFC294}"/>
              </a:ext>
            </a:extLst>
          </p:cNvPr>
          <p:cNvSpPr txBox="1"/>
          <p:nvPr/>
        </p:nvSpPr>
        <p:spPr>
          <a:xfrm>
            <a:off x="7472243" y="11409101"/>
            <a:ext cx="1052117" cy="311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RGDOX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8B7E6C2B-E83C-4328-AF77-64986F8FC3F5}"/>
              </a:ext>
            </a:extLst>
          </p:cNvPr>
          <p:cNvSpPr txBox="1"/>
          <p:nvPr/>
        </p:nvSpPr>
        <p:spPr>
          <a:xfrm>
            <a:off x="7472242" y="11710327"/>
            <a:ext cx="1427067" cy="311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T-cells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7E4D3E5-9CEF-4FAC-B0C6-31CE95A47C7F}"/>
              </a:ext>
            </a:extLst>
          </p:cNvPr>
          <p:cNvSpPr txBox="1"/>
          <p:nvPr/>
        </p:nvSpPr>
        <p:spPr>
          <a:xfrm>
            <a:off x="7472244" y="12008628"/>
            <a:ext cx="1427062" cy="530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RGDOX  + pmel-1 T-cells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E9547B2C-1201-4827-81F9-690E399BDF7E}"/>
              </a:ext>
            </a:extLst>
          </p:cNvPr>
          <p:cNvCxnSpPr/>
          <p:nvPr/>
        </p:nvCxnSpPr>
        <p:spPr>
          <a:xfrm>
            <a:off x="7288927" y="11265933"/>
            <a:ext cx="182336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36E615FD-3280-4C9A-B6BA-952BB5CEC29F}"/>
              </a:ext>
            </a:extLst>
          </p:cNvPr>
          <p:cNvCxnSpPr/>
          <p:nvPr/>
        </p:nvCxnSpPr>
        <p:spPr>
          <a:xfrm>
            <a:off x="7288927" y="11572030"/>
            <a:ext cx="182336" cy="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708BEB32-EC63-4AD4-9CC4-7B66E4782762}"/>
              </a:ext>
            </a:extLst>
          </p:cNvPr>
          <p:cNvCxnSpPr/>
          <p:nvPr/>
        </p:nvCxnSpPr>
        <p:spPr>
          <a:xfrm>
            <a:off x="7288927" y="12171557"/>
            <a:ext cx="182336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7EE9704D-1B36-4C5E-AF01-674D401D8F85}"/>
              </a:ext>
            </a:extLst>
          </p:cNvPr>
          <p:cNvCxnSpPr/>
          <p:nvPr/>
        </p:nvCxnSpPr>
        <p:spPr>
          <a:xfrm>
            <a:off x="7288927" y="11873257"/>
            <a:ext cx="182336" cy="0"/>
          </a:xfrm>
          <a:prstGeom prst="line">
            <a:avLst/>
          </a:prstGeom>
          <a:ln w="19050">
            <a:solidFill>
              <a:srgbClr val="FF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DDD3D234-501C-4F7C-9952-3CE96F2972A8}"/>
              </a:ext>
            </a:extLst>
          </p:cNvPr>
          <p:cNvCxnSpPr>
            <a:cxnSpLocks/>
          </p:cNvCxnSpPr>
          <p:nvPr/>
        </p:nvCxnSpPr>
        <p:spPr>
          <a:xfrm>
            <a:off x="8786616" y="11945320"/>
            <a:ext cx="0" cy="2983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061C667C-E457-40AB-BC52-4F0AE8715EED}"/>
              </a:ext>
            </a:extLst>
          </p:cNvPr>
          <p:cNvSpPr txBox="1"/>
          <p:nvPr/>
        </p:nvSpPr>
        <p:spPr>
          <a:xfrm>
            <a:off x="8736346" y="11899659"/>
            <a:ext cx="630464" cy="311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7A76CB8D-28B7-4D4E-B63A-38A4642FC1B7}"/>
              </a:ext>
            </a:extLst>
          </p:cNvPr>
          <p:cNvCxnSpPr>
            <a:cxnSpLocks/>
          </p:cNvCxnSpPr>
          <p:nvPr/>
        </p:nvCxnSpPr>
        <p:spPr>
          <a:xfrm>
            <a:off x="8792728" y="11291937"/>
            <a:ext cx="0" cy="58130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TextBox 205">
            <a:extLst>
              <a:ext uri="{FF2B5EF4-FFF2-40B4-BE49-F238E27FC236}">
                <a16:creationId xmlns:a16="http://schemas.microsoft.com/office/drawing/2014/main" id="{719408BB-FA36-4AD3-B823-55B09432FC37}"/>
              </a:ext>
            </a:extLst>
          </p:cNvPr>
          <p:cNvSpPr txBox="1"/>
          <p:nvPr/>
        </p:nvSpPr>
        <p:spPr>
          <a:xfrm>
            <a:off x="8763508" y="11445913"/>
            <a:ext cx="499689" cy="311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46901619-6FC3-4BD4-90BC-A6977A3494E8}"/>
              </a:ext>
            </a:extLst>
          </p:cNvPr>
          <p:cNvSpPr txBox="1"/>
          <p:nvPr/>
        </p:nvSpPr>
        <p:spPr>
          <a:xfrm rot="16200000">
            <a:off x="137403" y="8652469"/>
            <a:ext cx="23631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oluminescence (p/s)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04634022-171D-4822-84D2-7617DCA26FB1}"/>
              </a:ext>
            </a:extLst>
          </p:cNvPr>
          <p:cNvSpPr txBox="1"/>
          <p:nvPr/>
        </p:nvSpPr>
        <p:spPr>
          <a:xfrm rot="16200000">
            <a:off x="137403" y="5527666"/>
            <a:ext cx="23631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oluminescence (p/s)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6F64A376-2D79-466A-B310-7FAD52E66C37}"/>
              </a:ext>
            </a:extLst>
          </p:cNvPr>
          <p:cNvSpPr txBox="1"/>
          <p:nvPr/>
        </p:nvSpPr>
        <p:spPr>
          <a:xfrm>
            <a:off x="720294" y="3492196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B90E685-22FC-4C35-8FAA-47288E5B9C76}"/>
              </a:ext>
            </a:extLst>
          </p:cNvPr>
          <p:cNvSpPr txBox="1"/>
          <p:nvPr/>
        </p:nvSpPr>
        <p:spPr>
          <a:xfrm>
            <a:off x="720294" y="10583907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B0459290-ABE3-4CFA-BD27-9A70ADBDF8E3}"/>
              </a:ext>
            </a:extLst>
          </p:cNvPr>
          <p:cNvSpPr txBox="1"/>
          <p:nvPr/>
        </p:nvSpPr>
        <p:spPr>
          <a:xfrm>
            <a:off x="746261" y="13671944"/>
            <a:ext cx="105700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. S4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effect of combining pmel-1 T cells and Delta-24-RGDOX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cartoon depiction of the treatment scheme for schedule (left) and positions of tumor implantation, T-cell and virus injection (right).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subcutaneously; i.t.: intratumorally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Plots of the bioluminescence of the tumors from the indicated treatment groups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,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urvival plots of the treatment groups. n = 9 except n = 8 for combination group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GDOX: Delta-24-RGDOX. ns: not significant (p &gt; 0.05); **: p&lt;0.01. log-rank tes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8547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90</Words>
  <Application>Microsoft Office PowerPoint</Application>
  <PresentationFormat>Custom</PresentationFormat>
  <Paragraphs>2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7</cp:revision>
  <dcterms:created xsi:type="dcterms:W3CDTF">2022-10-17T17:34:53Z</dcterms:created>
  <dcterms:modified xsi:type="dcterms:W3CDTF">2023-03-08T16:33:53Z</dcterms:modified>
</cp:coreProperties>
</file>